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NI  " initials="KNI  " lastIdx="1" clrIdx="0"/>
  <p:cmAuthor id="1" name="KNI" initials="KN" lastIdx="1" clrIdx="1">
    <p:extLst>
      <p:ext uri="{19B8F6BF-5375-455C-9EA6-DF929625EA0E}">
        <p15:presenceInfo xmlns:p15="http://schemas.microsoft.com/office/powerpoint/2012/main" userId="KN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0035" autoAdjust="0"/>
    <p:restoredTop sz="94660"/>
  </p:normalViewPr>
  <p:slideViewPr>
    <p:cSldViewPr snapToGrid="0">
      <p:cViewPr varScale="1">
        <p:scale>
          <a:sx n="137" d="100"/>
          <a:sy n="137" d="100"/>
        </p:scale>
        <p:origin x="552" y="1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early-onset L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FD4A-4CFB-B167-1BBCC2C03FC9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FD4A-4CFB-B167-1BBCC2C03FC9}"/>
              </c:ext>
            </c:extLst>
          </c:dPt>
          <c:cat>
            <c:strRef>
              <c:f>Sheet1!$B$1:$C$1</c:f>
              <c:strCache>
                <c:ptCount val="2"/>
                <c:pt idx="0">
                  <c:v>6 months</c:v>
                </c:pt>
                <c:pt idx="1">
                  <c:v>12 months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52.21</c:v>
                </c:pt>
                <c:pt idx="1">
                  <c:v>63.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D4A-4CFB-B167-1BBCC2C03FC9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Late-onset LN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FD4A-4CFB-B167-1BBCC2C03FC9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4-FD4A-4CFB-B167-1BBCC2C03FC9}"/>
              </c:ext>
            </c:extLst>
          </c:dPt>
          <c:cat>
            <c:strRef>
              <c:f>Sheet1!$B$1:$C$1</c:f>
              <c:strCache>
                <c:ptCount val="2"/>
                <c:pt idx="0">
                  <c:v>6 months</c:v>
                </c:pt>
                <c:pt idx="1">
                  <c:v>12 months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35.21</c:v>
                </c:pt>
                <c:pt idx="1">
                  <c:v>47.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D4A-4CFB-B167-1BBCC2C03F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493504"/>
        <c:axId val="616500168"/>
      </c:barChart>
      <c:catAx>
        <c:axId val="616493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616500168"/>
        <c:crosses val="autoZero"/>
        <c:auto val="1"/>
        <c:lblAlgn val="ctr"/>
        <c:lblOffset val="100"/>
        <c:noMultiLvlLbl val="0"/>
      </c:catAx>
      <c:valAx>
        <c:axId val="616500168"/>
        <c:scaling>
          <c:orientation val="minMax"/>
          <c:max val="7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6164935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9120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518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497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4279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049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585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980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04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418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198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88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AD789-CD92-49B1-934D-717E3C2E1586}" type="datetimeFigureOut">
              <a:rPr kumimoji="1" lang="ja-JP" altLang="en-US" smtClean="0"/>
              <a:t>2020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1A7A7-EE77-45B3-A50E-2801105679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308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グループ化 21"/>
          <p:cNvGrpSpPr/>
          <p:nvPr/>
        </p:nvGrpSpPr>
        <p:grpSpPr>
          <a:xfrm>
            <a:off x="1812536" y="1800116"/>
            <a:ext cx="3333750" cy="3832578"/>
            <a:chOff x="1728033" y="1791878"/>
            <a:chExt cx="3333750" cy="3832578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2033056"/>
                </p:ext>
              </p:extLst>
            </p:nvPr>
          </p:nvGraphicFramePr>
          <p:xfrm>
            <a:off x="1728033" y="2295726"/>
            <a:ext cx="3333750" cy="26084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4"/>
            <p:cNvSpPr txBox="1"/>
            <p:nvPr/>
          </p:nvSpPr>
          <p:spPr>
            <a:xfrm>
              <a:off x="1728033" y="2018727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線コネクタ 5"/>
            <p:cNvCxnSpPr/>
            <p:nvPr/>
          </p:nvCxnSpPr>
          <p:spPr>
            <a:xfrm flipV="1">
              <a:off x="2388096" y="2387358"/>
              <a:ext cx="64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 flipV="1">
              <a:off x="3844002" y="2387358"/>
              <a:ext cx="64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2332024" y="2083486"/>
              <a:ext cx="7521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=0.033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731858" y="2077465"/>
              <a:ext cx="7521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=0.046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550032" y="1791878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005938" y="1791878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2583476" y="5041994"/>
              <a:ext cx="126459" cy="1361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2583475" y="5387086"/>
              <a:ext cx="126459" cy="1361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2797486" y="4940810"/>
              <a:ext cx="16321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arly-onset LN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797485" y="5285902"/>
              <a:ext cx="15520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ate-onset LN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2529158" y="4931082"/>
              <a:ext cx="1900506" cy="6836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385315" y="2725833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2.2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794684" y="3194894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.2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786434" y="2402435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3.7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4188252" y="2817933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7.9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2200856" y="8413513"/>
            <a:ext cx="2557110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. Fig. </a:t>
            </a:r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663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</TotalTime>
  <Words>18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hinose Kunihiro</dc:creator>
  <cp:lastModifiedBy>Ichinose Kunihiro</cp:lastModifiedBy>
  <cp:revision>5</cp:revision>
  <dcterms:created xsi:type="dcterms:W3CDTF">2020-04-18T06:29:04Z</dcterms:created>
  <dcterms:modified xsi:type="dcterms:W3CDTF">2020-07-06T11:33:33Z</dcterms:modified>
</cp:coreProperties>
</file>